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21A958A-0F61-4B45-BF25-C08969390D5C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34D72A9-8C8A-46B5-A625-A2128E3713A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CD422F4-6AA2-43A7-84C0-D07B348B3D13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0439E1A-CDC0-49DB-8BF6-D40AE1677718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D37D81F-EB2E-478F-9272-EABFD896358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01DF084-14AF-4295-8A20-F2B9158B554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A108A30-9D0B-4BE5-AC41-993D1417F74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1493D92-DEF2-42A4-9020-236357AA1C8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ECB6EA7-11E3-41F0-B15E-F067E885DF8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13A6826-320A-4BAE-B03E-068276B483E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6F49D64-2D26-4BA4-B42A-932BC74506E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71854C5-1E92-434F-A115-8B45E64A030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3FF5093-7AFD-43D8-A549-4E69F90A41C7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1" name=""/>
          <p:cNvGraphicFramePr/>
          <p:nvPr/>
        </p:nvGraphicFramePr>
        <p:xfrm>
          <a:off x="216000" y="252360"/>
          <a:ext cx="6857640" cy="4339800"/>
        </p:xfrm>
        <a:graphic>
          <a:graphicData uri="http://schemas.openxmlformats.org/drawingml/2006/table">
            <a:tbl>
              <a:tblPr/>
              <a:tblGrid>
                <a:gridCol w="779760"/>
                <a:gridCol w="156240"/>
                <a:gridCol w="388440"/>
                <a:gridCol w="2961360"/>
                <a:gridCol w="2571840"/>
              </a:tblGrid>
              <a:tr h="219240">
                <a:tc>
                  <a:txBody>
                    <a:bodyPr lIns="0" rIns="0" tIns="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Genes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gridSpan="2">
                  <a:txBody>
                    <a:bodyPr lIns="0" rIns="0" tIns="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RNA and EST EMBL accession numbers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0" rIns="0" tIns="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Expressed in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774360">
                <a:tc rowSpan="3">
                  <a:txBody>
                    <a:bodyPr lIns="0" rIns="0" tIns="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RdCVF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rowSpan="2">
                  <a:txBody>
                    <a:bodyPr lIns="0" rIns="0" tIns="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L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0 :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BC021911 ; BI738445 ; CB849876 ; CK623520 ; BI731629 ; BI872244 ; BG294111 ; BI734135 ; BU505070 ; BU840744 ; BQ929742 ; BQ938066 ; BI73223 ; CK628091 ; BY742305 ; CN539863 ; CO424399 ; BB277874 ; BB279867 ; CO42641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retina, RPE, choroid and/or ey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32256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0" rIns="0" tIns="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 :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BF470336 ; BE983242 ; AW49518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on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8880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0" rIns="0" tIns="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S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4 :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BC017153 ; CB849876 ; BG299078 ; BY74229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Retina and/or ey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464400">
                <a:tc rowSpan="13">
                  <a:txBody>
                    <a:bodyPr lIns="0" rIns="0" tIns="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RdCVF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 rowSpan="11">
                  <a:txBody>
                    <a:bodyPr lIns="0" rIns="0" tIns="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L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0 :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K621895 ; CK620198 ; BG288447 ; BB282056 ; BB279962 ; BB281743 ; BB277718 ; BB277574 ; BB277714 ; BI73242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retina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30924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0" rIns="0" tIns="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 :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BC038905 ; BI10874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ammary tumor, tumor and/or gross tissu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5516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0" rIns="0" tIns="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 :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BY715393 ; AV26669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estis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5480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0" rIns="0" tIns="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 :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DT90680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hematopoietic stem cells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5480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0" rIns="0" tIns="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 :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BY43508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mnion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5480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0" rIns="0" tIns="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 :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I32409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lacenta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5480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0" rIns="0" tIns="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 :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BB55211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oviduct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5480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0" rIns="0" tIns="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 :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A26123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fetus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5516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0" rIns="0" tIns="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 :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BB24136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hymus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5444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0" rIns="0" tIns="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 :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I53647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ammary gland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1284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0" rIns="0" tIns="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 :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BX632214 ; BF460609 ; BX51447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on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5516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rowSpan="2">
                  <a:txBody>
                    <a:bodyPr lIns="0" rIns="0" tIns="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S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 :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BC016199 ; BG297304 ; BG29738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retina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15444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0" rIns="0" tIns="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 :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BX51447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on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42" name=""/>
          <p:cNvSpPr/>
          <p:nvPr/>
        </p:nvSpPr>
        <p:spPr>
          <a:xfrm>
            <a:off x="2384280" y="5180040"/>
            <a:ext cx="2521080" cy="21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59760" tIns="0" bIns="0" anchor="ctr">
            <a:noAutofit/>
          </a:bodyPr>
          <a:p>
            <a:pPr algn="ctr">
              <a:tabLst>
                <a:tab algn="l" pos="0"/>
                <a:tab algn="l" pos="1512720"/>
                <a:tab algn="l" pos="3025800"/>
                <a:tab algn="l" pos="4538520"/>
                <a:tab algn="l" pos="6051600"/>
                <a:tab algn="l" pos="7564320"/>
                <a:tab algn="l" pos="9077400"/>
                <a:tab algn="l" pos="10590120"/>
              </a:tabLst>
            </a:pPr>
            <a:r>
              <a:rPr b="1" lang="fr-FR" sz="1000" spc="-1" strike="noStrike">
                <a:solidFill>
                  <a:srgbClr val="000000"/>
                </a:solidFill>
                <a:latin typeface="Arial"/>
              </a:rPr>
              <a:t>Supplementary  information 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7-01-08T13:13:12Z</dcterms:created>
  <dc:creator>celine</dc:creator>
  <dc:description/>
  <dc:language>en-US</dc:language>
  <cp:lastModifiedBy>celine</cp:lastModifiedBy>
  <dcterms:modified xsi:type="dcterms:W3CDTF">2007-01-08T13:13:37Z</dcterms:modified>
  <cp:revision>1</cp:revision>
  <dc:subject/>
  <dc:title>Diapositive 1</dc:title>
</cp:coreProperties>
</file>